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39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661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8591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2867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6660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0949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9223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3508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9060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8239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6388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BEF93C-0B08-4EB9-B75C-54B2EA47B39D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1BFE0-2BC0-407A-A0D8-C0D92F04722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6290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JP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3279770"/>
              </p:ext>
            </p:extLst>
          </p:nvPr>
        </p:nvGraphicFramePr>
        <p:xfrm>
          <a:off x="4473171" y="2105025"/>
          <a:ext cx="3859213" cy="2646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5" r:id="rId3" imgW="3858840" imgH="2647080" progId="Prism5.Document">
                  <p:embed/>
                </p:oleObj>
              </mc:Choice>
              <mc:Fallback>
                <p:oleObj name="Prism 5" r:id="rId3" imgW="3858840" imgH="264708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73171" y="2105025"/>
                        <a:ext cx="3859213" cy="2646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Image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7224" y="2244003"/>
            <a:ext cx="1543050" cy="79057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3024273" y="4751388"/>
            <a:ext cx="692606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900" b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5 Fig: </a:t>
            </a:r>
            <a:r>
              <a:rPr lang="en-US" sz="9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mparison of the efficacy of VV on </a:t>
            </a:r>
            <a:r>
              <a:rPr lang="en-US" sz="9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lls from the two TNBC samples used in the single cell </a:t>
            </a:r>
            <a:r>
              <a:rPr lang="en-US" sz="900" b="1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nscriptomics</a:t>
            </a:r>
            <a:r>
              <a:rPr lang="en-US" sz="9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xperiment</a:t>
            </a:r>
            <a:r>
              <a:rPr lang="en-US" sz="9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imary canine cells </a:t>
            </a:r>
            <a:r>
              <a:rPr lang="en-US" sz="9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rom TNBC origin used in single-cell </a:t>
            </a:r>
            <a:r>
              <a:rPr lang="en-US" sz="9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anscriptomics</a:t>
            </a:r>
            <a:r>
              <a:rPr lang="en-US" sz="9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xperiments 1 and 2 were </a:t>
            </a:r>
            <a:r>
              <a:rPr lang="en-US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fected at different MOIs with VV. Fours days later, the remaining cells were estimated using a MTT assay. The results are presented as a percentage of cell-survival in uninfected cells and are mean +/- SEM of six different experimental points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is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sult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s representative of two independent determinations.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4900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92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ism 5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eorges I</dc:creator>
  <cp:lastModifiedBy>Georges I</cp:lastModifiedBy>
  <cp:revision>5</cp:revision>
  <dcterms:created xsi:type="dcterms:W3CDTF">2020-07-23T15:19:13Z</dcterms:created>
  <dcterms:modified xsi:type="dcterms:W3CDTF">2020-10-01T13:26:01Z</dcterms:modified>
</cp:coreProperties>
</file>